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9388475" cy="71024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 " initials="" lastIdx="1" clrIdx="0">
    <p:extLst>
      <p:ext uri="{19B8F6BF-5375-455C-9EA6-DF929625EA0E}">
        <p15:presenceInfo xmlns:p15="http://schemas.microsoft.com/office/powerpoint/2012/main" userId="b58784fc3065127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48" y="83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8841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3750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8276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1076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4887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5473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810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0332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170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4869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074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171AD-1CC1-4D38-B17D-B491FE47D7F3}" type="datetimeFigureOut">
              <a:rPr lang="ko-KR" altLang="en-US" smtClean="0"/>
              <a:t>2020-07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A7DC1-5F00-4B1C-ACE8-AF4F136DAAE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396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화살표: 왼쪽 37">
            <a:extLst>
              <a:ext uri="{FF2B5EF4-FFF2-40B4-BE49-F238E27FC236}">
                <a16:creationId xmlns:a16="http://schemas.microsoft.com/office/drawing/2014/main" id="{3043B379-D75F-425E-8090-0F8EAA5EF37F}"/>
              </a:ext>
            </a:extLst>
          </p:cNvPr>
          <p:cNvSpPr/>
          <p:nvPr/>
        </p:nvSpPr>
        <p:spPr>
          <a:xfrm>
            <a:off x="2523058" y="3283785"/>
            <a:ext cx="833077" cy="317326"/>
          </a:xfrm>
          <a:prstGeom prst="lef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화살표: 아래쪽 31">
            <a:extLst>
              <a:ext uri="{FF2B5EF4-FFF2-40B4-BE49-F238E27FC236}">
                <a16:creationId xmlns:a16="http://schemas.microsoft.com/office/drawing/2014/main" id="{1DCCBB31-36F9-4972-8E8B-7F889CCFFAE9}"/>
              </a:ext>
            </a:extLst>
          </p:cNvPr>
          <p:cNvSpPr/>
          <p:nvPr/>
        </p:nvSpPr>
        <p:spPr>
          <a:xfrm rot="8300424">
            <a:off x="5090310" y="4214891"/>
            <a:ext cx="182880" cy="2152586"/>
          </a:xfrm>
          <a:prstGeom prst="downArrow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화살표: 아래쪽 30">
            <a:extLst>
              <a:ext uri="{FF2B5EF4-FFF2-40B4-BE49-F238E27FC236}">
                <a16:creationId xmlns:a16="http://schemas.microsoft.com/office/drawing/2014/main" id="{5AB7C49C-1FB7-4CF3-A14F-61125D04CAA5}"/>
              </a:ext>
            </a:extLst>
          </p:cNvPr>
          <p:cNvSpPr/>
          <p:nvPr/>
        </p:nvSpPr>
        <p:spPr>
          <a:xfrm rot="7561153">
            <a:off x="5483524" y="3794331"/>
            <a:ext cx="182880" cy="1645920"/>
          </a:xfrm>
          <a:prstGeom prst="downArrow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0" name="화살표: 아래쪽 29">
            <a:extLst>
              <a:ext uri="{FF2B5EF4-FFF2-40B4-BE49-F238E27FC236}">
                <a16:creationId xmlns:a16="http://schemas.microsoft.com/office/drawing/2014/main" id="{30F16647-005A-423F-A3B7-63530F34B362}"/>
              </a:ext>
            </a:extLst>
          </p:cNvPr>
          <p:cNvSpPr/>
          <p:nvPr/>
        </p:nvSpPr>
        <p:spPr>
          <a:xfrm rot="5400000">
            <a:off x="5996837" y="2364766"/>
            <a:ext cx="182880" cy="1883974"/>
          </a:xfrm>
          <a:prstGeom prst="downArrow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화살표: 아래쪽 28">
            <a:extLst>
              <a:ext uri="{FF2B5EF4-FFF2-40B4-BE49-F238E27FC236}">
                <a16:creationId xmlns:a16="http://schemas.microsoft.com/office/drawing/2014/main" id="{BE24F09D-5585-482F-89A2-C99EF7952FBC}"/>
              </a:ext>
            </a:extLst>
          </p:cNvPr>
          <p:cNvSpPr/>
          <p:nvPr/>
        </p:nvSpPr>
        <p:spPr>
          <a:xfrm rot="2865795">
            <a:off x="5371033" y="1693058"/>
            <a:ext cx="182880" cy="1280160"/>
          </a:xfrm>
          <a:prstGeom prst="downArrow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화살표: 아래쪽 27">
            <a:extLst>
              <a:ext uri="{FF2B5EF4-FFF2-40B4-BE49-F238E27FC236}">
                <a16:creationId xmlns:a16="http://schemas.microsoft.com/office/drawing/2014/main" id="{6355CB94-0893-4BF6-8D72-3175A987F1CB}"/>
              </a:ext>
            </a:extLst>
          </p:cNvPr>
          <p:cNvSpPr/>
          <p:nvPr/>
        </p:nvSpPr>
        <p:spPr>
          <a:xfrm rot="2146147">
            <a:off x="5120160" y="596547"/>
            <a:ext cx="182880" cy="2060011"/>
          </a:xfrm>
          <a:prstGeom prst="downArrow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타원 11">
            <a:extLst>
              <a:ext uri="{FF2B5EF4-FFF2-40B4-BE49-F238E27FC236}">
                <a16:creationId xmlns:a16="http://schemas.microsoft.com/office/drawing/2014/main" id="{52BF6268-CBE9-46AC-A3C7-EA23371ACAEE}"/>
              </a:ext>
            </a:extLst>
          </p:cNvPr>
          <p:cNvSpPr/>
          <p:nvPr/>
        </p:nvSpPr>
        <p:spPr>
          <a:xfrm>
            <a:off x="3000677" y="2356855"/>
            <a:ext cx="2149103" cy="2149103"/>
          </a:xfrm>
          <a:prstGeom prst="ellipse">
            <a:avLst/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2">
              <a:hueOff val="0"/>
              <a:satOff val="0"/>
              <a:lumOff val="0"/>
              <a:alphaOff val="0"/>
            </a:schemeClr>
          </a:fillRef>
          <a:effectRef idx="0">
            <a:schemeClr val="accent2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14" name="자유형: 도형 13">
            <a:extLst>
              <a:ext uri="{FF2B5EF4-FFF2-40B4-BE49-F238E27FC236}">
                <a16:creationId xmlns:a16="http://schemas.microsoft.com/office/drawing/2014/main" id="{1DCDA1AC-BC13-4A59-9055-5F1CEBB6BD0F}"/>
              </a:ext>
            </a:extLst>
          </p:cNvPr>
          <p:cNvSpPr/>
          <p:nvPr/>
        </p:nvSpPr>
        <p:spPr>
          <a:xfrm>
            <a:off x="8327687" y="5960631"/>
            <a:ext cx="4448266" cy="794503"/>
          </a:xfrm>
          <a:custGeom>
            <a:avLst/>
            <a:gdLst>
              <a:gd name="connsiteX0" fmla="*/ 0 w 1934192"/>
              <a:gd name="connsiteY0" fmla="*/ 0 h 1289461"/>
              <a:gd name="connsiteX1" fmla="*/ 1934192 w 1934192"/>
              <a:gd name="connsiteY1" fmla="*/ 0 h 1289461"/>
              <a:gd name="connsiteX2" fmla="*/ 1934192 w 1934192"/>
              <a:gd name="connsiteY2" fmla="*/ 1289461 h 1289461"/>
              <a:gd name="connsiteX3" fmla="*/ 0 w 1934192"/>
              <a:gd name="connsiteY3" fmla="*/ 1289461 h 1289461"/>
              <a:gd name="connsiteX4" fmla="*/ 0 w 1934192"/>
              <a:gd name="connsiteY4" fmla="*/ 0 h 12894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934192" h="1289461">
                <a:moveTo>
                  <a:pt x="0" y="0"/>
                </a:moveTo>
                <a:lnTo>
                  <a:pt x="1934192" y="0"/>
                </a:lnTo>
                <a:lnTo>
                  <a:pt x="1934192" y="1289461"/>
                </a:lnTo>
                <a:lnTo>
                  <a:pt x="0" y="1289461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0" rIns="0" bIns="0" numCol="1" spcCol="1270" anchor="ctr" anchorCtr="0">
            <a:noAutofit/>
          </a:bodyPr>
          <a:lstStyle/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20) environmental movement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21) recycling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22) nature protection</a:t>
            </a:r>
            <a:endParaRPr lang="ko-KR" altLang="en-US" sz="2000" dirty="0"/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  <a:buChar char="•"/>
            </a:pPr>
            <a:endParaRPr lang="ko-KR" altLang="en-US" sz="2000" dirty="0"/>
          </a:p>
        </p:txBody>
      </p:sp>
      <p:sp>
        <p:nvSpPr>
          <p:cNvPr id="16" name="자유형: 도형 15">
            <a:extLst>
              <a:ext uri="{FF2B5EF4-FFF2-40B4-BE49-F238E27FC236}">
                <a16:creationId xmlns:a16="http://schemas.microsoft.com/office/drawing/2014/main" id="{EDDF4CF4-A9AB-4060-8FD6-5D2562AC0C3F}"/>
              </a:ext>
            </a:extLst>
          </p:cNvPr>
          <p:cNvSpPr/>
          <p:nvPr/>
        </p:nvSpPr>
        <p:spPr>
          <a:xfrm>
            <a:off x="7305430" y="1954133"/>
            <a:ext cx="1934192" cy="1289461"/>
          </a:xfrm>
          <a:custGeom>
            <a:avLst/>
            <a:gdLst>
              <a:gd name="connsiteX0" fmla="*/ 0 w 1934192"/>
              <a:gd name="connsiteY0" fmla="*/ 0 h 1289461"/>
              <a:gd name="connsiteX1" fmla="*/ 1934192 w 1934192"/>
              <a:gd name="connsiteY1" fmla="*/ 0 h 1289461"/>
              <a:gd name="connsiteX2" fmla="*/ 1934192 w 1934192"/>
              <a:gd name="connsiteY2" fmla="*/ 1289461 h 1289461"/>
              <a:gd name="connsiteX3" fmla="*/ 0 w 1934192"/>
              <a:gd name="connsiteY3" fmla="*/ 1289461 h 1289461"/>
              <a:gd name="connsiteX4" fmla="*/ 0 w 1934192"/>
              <a:gd name="connsiteY4" fmla="*/ 0 h 12894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934192" h="1289461">
                <a:moveTo>
                  <a:pt x="0" y="0"/>
                </a:moveTo>
                <a:lnTo>
                  <a:pt x="1934192" y="0"/>
                </a:lnTo>
                <a:lnTo>
                  <a:pt x="1934192" y="1289461"/>
                </a:lnTo>
                <a:lnTo>
                  <a:pt x="0" y="1289461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0" rIns="0" bIns="0" numCol="1" spcCol="1270" anchor="ctr" anchorCtr="0">
            <a:noAutofit/>
          </a:bodyPr>
          <a:lstStyle/>
          <a:p>
            <a:pPr marL="228600" lvl="1" indent="-228600" defTabSz="977900" latinLnBrk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endParaRPr lang="ko-KR" altLang="en-US" sz="2200"/>
          </a:p>
          <a:p>
            <a:pPr marL="228600" lvl="1" indent="-228600" defTabSz="977900" latinLnBrk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endParaRPr lang="ko-KR" altLang="en-US" sz="2200"/>
          </a:p>
        </p:txBody>
      </p:sp>
      <p:sp>
        <p:nvSpPr>
          <p:cNvPr id="18" name="자유형: 도형 17">
            <a:extLst>
              <a:ext uri="{FF2B5EF4-FFF2-40B4-BE49-F238E27FC236}">
                <a16:creationId xmlns:a16="http://schemas.microsoft.com/office/drawing/2014/main" id="{3B010771-65EA-49DC-801D-68351403A2E1}"/>
              </a:ext>
            </a:extLst>
          </p:cNvPr>
          <p:cNvSpPr/>
          <p:nvPr/>
        </p:nvSpPr>
        <p:spPr>
          <a:xfrm>
            <a:off x="7305430" y="3619219"/>
            <a:ext cx="1934192" cy="1289461"/>
          </a:xfrm>
          <a:custGeom>
            <a:avLst/>
            <a:gdLst>
              <a:gd name="connsiteX0" fmla="*/ 0 w 1934192"/>
              <a:gd name="connsiteY0" fmla="*/ 0 h 1289461"/>
              <a:gd name="connsiteX1" fmla="*/ 1934192 w 1934192"/>
              <a:gd name="connsiteY1" fmla="*/ 0 h 1289461"/>
              <a:gd name="connsiteX2" fmla="*/ 1934192 w 1934192"/>
              <a:gd name="connsiteY2" fmla="*/ 1289461 h 1289461"/>
              <a:gd name="connsiteX3" fmla="*/ 0 w 1934192"/>
              <a:gd name="connsiteY3" fmla="*/ 1289461 h 1289461"/>
              <a:gd name="connsiteX4" fmla="*/ 0 w 1934192"/>
              <a:gd name="connsiteY4" fmla="*/ 0 h 12894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934192" h="1289461">
                <a:moveTo>
                  <a:pt x="0" y="0"/>
                </a:moveTo>
                <a:lnTo>
                  <a:pt x="1934192" y="0"/>
                </a:lnTo>
                <a:lnTo>
                  <a:pt x="1934192" y="1289461"/>
                </a:lnTo>
                <a:lnTo>
                  <a:pt x="0" y="1289461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0" rIns="0" bIns="0" numCol="1" spcCol="1270" anchor="ctr" anchorCtr="0">
            <a:noAutofit/>
          </a:bodyPr>
          <a:lstStyle/>
          <a:p>
            <a:pPr marL="228600" lvl="1" indent="-228600" defTabSz="977900" latinLnBrk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endParaRPr lang="ko-KR" altLang="en-US" sz="2200"/>
          </a:p>
          <a:p>
            <a:pPr marL="228600" lvl="1" indent="-228600" defTabSz="977900" latinLnBrk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endParaRPr lang="ko-KR" altLang="en-US" sz="220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E290030-C7E6-4217-ADF5-523152BC0ED3}"/>
              </a:ext>
            </a:extLst>
          </p:cNvPr>
          <p:cNvSpPr txBox="1"/>
          <p:nvPr/>
        </p:nvSpPr>
        <p:spPr>
          <a:xfrm>
            <a:off x="3101293" y="3027569"/>
            <a:ext cx="191507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dirty="0"/>
              <a:t>Sustainability </a:t>
            </a:r>
          </a:p>
          <a:p>
            <a:pPr algn="ctr"/>
            <a:r>
              <a:rPr lang="en-US" altLang="ko-KR" sz="2400" dirty="0"/>
              <a:t>for Church</a:t>
            </a:r>
            <a:endParaRPr lang="ko-KR" altLang="en-US" sz="2400" dirty="0"/>
          </a:p>
        </p:txBody>
      </p:sp>
      <p:sp>
        <p:nvSpPr>
          <p:cNvPr id="20" name="자유형: 도형 19">
            <a:extLst>
              <a:ext uri="{FF2B5EF4-FFF2-40B4-BE49-F238E27FC236}">
                <a16:creationId xmlns:a16="http://schemas.microsoft.com/office/drawing/2014/main" id="{DE746181-C3BB-41D6-8B24-61FCEC2C055C}"/>
              </a:ext>
            </a:extLst>
          </p:cNvPr>
          <p:cNvSpPr/>
          <p:nvPr/>
        </p:nvSpPr>
        <p:spPr>
          <a:xfrm>
            <a:off x="8346062" y="2895042"/>
            <a:ext cx="4448266" cy="1158024"/>
          </a:xfrm>
          <a:custGeom>
            <a:avLst/>
            <a:gdLst>
              <a:gd name="connsiteX0" fmla="*/ 0 w 1934192"/>
              <a:gd name="connsiteY0" fmla="*/ 0 h 1289461"/>
              <a:gd name="connsiteX1" fmla="*/ 1934192 w 1934192"/>
              <a:gd name="connsiteY1" fmla="*/ 0 h 1289461"/>
              <a:gd name="connsiteX2" fmla="*/ 1934192 w 1934192"/>
              <a:gd name="connsiteY2" fmla="*/ 1289461 h 1289461"/>
              <a:gd name="connsiteX3" fmla="*/ 0 w 1934192"/>
              <a:gd name="connsiteY3" fmla="*/ 1289461 h 1289461"/>
              <a:gd name="connsiteX4" fmla="*/ 0 w 1934192"/>
              <a:gd name="connsiteY4" fmla="*/ 0 h 12894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934192" h="1289461">
                <a:moveTo>
                  <a:pt x="0" y="0"/>
                </a:moveTo>
                <a:lnTo>
                  <a:pt x="1934192" y="0"/>
                </a:lnTo>
                <a:lnTo>
                  <a:pt x="1934192" y="1289461"/>
                </a:lnTo>
                <a:lnTo>
                  <a:pt x="0" y="1289461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0" rIns="0" bIns="0" numCol="1" spcCol="1270" anchor="ctr" anchorCtr="0">
            <a:noAutofit/>
          </a:bodyPr>
          <a:lstStyle/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8) serving the elderly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9) shelter disability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0) care single family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1) helping poor people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2) disaster relief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3) volunteer</a:t>
            </a:r>
            <a:endParaRPr lang="ko-KR" altLang="en-US" sz="2000" dirty="0"/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4) giving goods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5) sharing necessities</a:t>
            </a:r>
            <a:endParaRPr lang="ko-KR" altLang="en-US" sz="2000" dirty="0"/>
          </a:p>
        </p:txBody>
      </p:sp>
      <p:sp>
        <p:nvSpPr>
          <p:cNvPr id="23" name="사각형: 둥근 모서리 22">
            <a:extLst>
              <a:ext uri="{FF2B5EF4-FFF2-40B4-BE49-F238E27FC236}">
                <a16:creationId xmlns:a16="http://schemas.microsoft.com/office/drawing/2014/main" id="{5A829A1A-3393-4849-900E-C7B0F5242166}"/>
              </a:ext>
            </a:extLst>
          </p:cNvPr>
          <p:cNvSpPr/>
          <p:nvPr/>
        </p:nvSpPr>
        <p:spPr>
          <a:xfrm>
            <a:off x="5731229" y="5844961"/>
            <a:ext cx="2406416" cy="728844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88950" latinLnBrk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altLang="ko-KR" sz="2400" dirty="0"/>
              <a:t>Environmental</a:t>
            </a:r>
            <a:endParaRPr lang="ko-KR" altLang="en-US" sz="2400" dirty="0"/>
          </a:p>
        </p:txBody>
      </p:sp>
      <p:sp>
        <p:nvSpPr>
          <p:cNvPr id="24" name="사각형: 둥근 모서리 23">
            <a:extLst>
              <a:ext uri="{FF2B5EF4-FFF2-40B4-BE49-F238E27FC236}">
                <a16:creationId xmlns:a16="http://schemas.microsoft.com/office/drawing/2014/main" id="{F7EE1E4F-675C-4FAA-BA06-A87048CAEC1D}"/>
              </a:ext>
            </a:extLst>
          </p:cNvPr>
          <p:cNvSpPr/>
          <p:nvPr/>
        </p:nvSpPr>
        <p:spPr>
          <a:xfrm>
            <a:off x="5731835" y="2914647"/>
            <a:ext cx="2406416" cy="728844"/>
          </a:xfrm>
          <a:prstGeom prst="round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88950" latinLnBrk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altLang="ko-KR" sz="2400" dirty="0"/>
              <a:t>Social </a:t>
            </a:r>
            <a:endParaRPr lang="ko-KR" altLang="en-US" sz="2400" dirty="0"/>
          </a:p>
        </p:txBody>
      </p:sp>
      <p:sp>
        <p:nvSpPr>
          <p:cNvPr id="25" name="사각형: 둥근 모서리 24">
            <a:extLst>
              <a:ext uri="{FF2B5EF4-FFF2-40B4-BE49-F238E27FC236}">
                <a16:creationId xmlns:a16="http://schemas.microsoft.com/office/drawing/2014/main" id="{D098B7DD-63AE-4B1F-A070-466BDDBBE58F}"/>
              </a:ext>
            </a:extLst>
          </p:cNvPr>
          <p:cNvSpPr/>
          <p:nvPr/>
        </p:nvSpPr>
        <p:spPr>
          <a:xfrm>
            <a:off x="5724025" y="369558"/>
            <a:ext cx="2406416" cy="728844"/>
          </a:xfrm>
          <a:prstGeom prst="round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88950" latinLnBrk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altLang="ko-KR" sz="2400" dirty="0"/>
              <a:t>Economical </a:t>
            </a:r>
            <a:endParaRPr lang="ko-KR" altLang="en-US" sz="2400" dirty="0"/>
          </a:p>
        </p:txBody>
      </p:sp>
      <p:sp>
        <p:nvSpPr>
          <p:cNvPr id="26" name="사각형: 둥근 모서리 25">
            <a:extLst>
              <a:ext uri="{FF2B5EF4-FFF2-40B4-BE49-F238E27FC236}">
                <a16:creationId xmlns:a16="http://schemas.microsoft.com/office/drawing/2014/main" id="{D2A1B51E-ABA8-4059-9172-E4CE9D983552}"/>
              </a:ext>
            </a:extLst>
          </p:cNvPr>
          <p:cNvSpPr/>
          <p:nvPr/>
        </p:nvSpPr>
        <p:spPr>
          <a:xfrm>
            <a:off x="5718959" y="4680583"/>
            <a:ext cx="2406416" cy="728844"/>
          </a:xfrm>
          <a:prstGeom prst="round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88950" latinLnBrk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altLang="ko-KR" sz="2400" dirty="0"/>
              <a:t>Political </a:t>
            </a:r>
            <a:endParaRPr lang="ko-KR" altLang="en-US" sz="2400" dirty="0"/>
          </a:p>
        </p:txBody>
      </p:sp>
      <p:sp>
        <p:nvSpPr>
          <p:cNvPr id="27" name="사각형: 둥근 모서리 26">
            <a:extLst>
              <a:ext uri="{FF2B5EF4-FFF2-40B4-BE49-F238E27FC236}">
                <a16:creationId xmlns:a16="http://schemas.microsoft.com/office/drawing/2014/main" id="{C5539200-E59A-45F2-87E8-F00E0CE519AE}"/>
              </a:ext>
            </a:extLst>
          </p:cNvPr>
          <p:cNvSpPr/>
          <p:nvPr/>
        </p:nvSpPr>
        <p:spPr>
          <a:xfrm>
            <a:off x="5713468" y="1436080"/>
            <a:ext cx="2406416" cy="728844"/>
          </a:xfrm>
          <a:prstGeom prst="round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88950" latinLnBrk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altLang="ko-KR" sz="2400" dirty="0"/>
              <a:t>Educational </a:t>
            </a:r>
            <a:endParaRPr lang="ko-KR" altLang="en-US" sz="2400" dirty="0"/>
          </a:p>
        </p:txBody>
      </p:sp>
      <p:sp>
        <p:nvSpPr>
          <p:cNvPr id="33" name="자유형: 도형 32">
            <a:extLst>
              <a:ext uri="{FF2B5EF4-FFF2-40B4-BE49-F238E27FC236}">
                <a16:creationId xmlns:a16="http://schemas.microsoft.com/office/drawing/2014/main" id="{98914282-7114-42E3-8C05-0CB01994BB88}"/>
              </a:ext>
            </a:extLst>
          </p:cNvPr>
          <p:cNvSpPr/>
          <p:nvPr/>
        </p:nvSpPr>
        <p:spPr>
          <a:xfrm>
            <a:off x="8332644" y="264454"/>
            <a:ext cx="4448266" cy="886579"/>
          </a:xfrm>
          <a:custGeom>
            <a:avLst/>
            <a:gdLst>
              <a:gd name="connsiteX0" fmla="*/ 0 w 1934192"/>
              <a:gd name="connsiteY0" fmla="*/ 0 h 1289461"/>
              <a:gd name="connsiteX1" fmla="*/ 1934192 w 1934192"/>
              <a:gd name="connsiteY1" fmla="*/ 0 h 1289461"/>
              <a:gd name="connsiteX2" fmla="*/ 1934192 w 1934192"/>
              <a:gd name="connsiteY2" fmla="*/ 1289461 h 1289461"/>
              <a:gd name="connsiteX3" fmla="*/ 0 w 1934192"/>
              <a:gd name="connsiteY3" fmla="*/ 1289461 h 1289461"/>
              <a:gd name="connsiteX4" fmla="*/ 0 w 1934192"/>
              <a:gd name="connsiteY4" fmla="*/ 0 h 12894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934192" h="1289461">
                <a:moveTo>
                  <a:pt x="0" y="0"/>
                </a:moveTo>
                <a:lnTo>
                  <a:pt x="1934192" y="0"/>
                </a:lnTo>
                <a:lnTo>
                  <a:pt x="1934192" y="1289461"/>
                </a:lnTo>
                <a:lnTo>
                  <a:pt x="0" y="1289461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0" rIns="0" bIns="0" numCol="1" spcCol="1270" anchor="ctr" anchorCtr="0">
            <a:noAutofit/>
          </a:bodyPr>
          <a:lstStyle/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) donation</a:t>
            </a:r>
            <a:endParaRPr lang="ko-KR" altLang="en-US" sz="2000" dirty="0"/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2) bazaar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3) fundraising</a:t>
            </a:r>
            <a:endParaRPr lang="ko-KR" altLang="en-US" sz="2000" dirty="0"/>
          </a:p>
        </p:txBody>
      </p:sp>
      <p:sp>
        <p:nvSpPr>
          <p:cNvPr id="34" name="자유형: 도형 33">
            <a:extLst>
              <a:ext uri="{FF2B5EF4-FFF2-40B4-BE49-F238E27FC236}">
                <a16:creationId xmlns:a16="http://schemas.microsoft.com/office/drawing/2014/main" id="{A37E364E-DA47-44F1-9188-4CEBFD74F3E1}"/>
              </a:ext>
            </a:extLst>
          </p:cNvPr>
          <p:cNvSpPr/>
          <p:nvPr/>
        </p:nvSpPr>
        <p:spPr>
          <a:xfrm>
            <a:off x="8323814" y="4670341"/>
            <a:ext cx="4448266" cy="886579"/>
          </a:xfrm>
          <a:custGeom>
            <a:avLst/>
            <a:gdLst>
              <a:gd name="connsiteX0" fmla="*/ 0 w 1934192"/>
              <a:gd name="connsiteY0" fmla="*/ 0 h 1289461"/>
              <a:gd name="connsiteX1" fmla="*/ 1934192 w 1934192"/>
              <a:gd name="connsiteY1" fmla="*/ 0 h 1289461"/>
              <a:gd name="connsiteX2" fmla="*/ 1934192 w 1934192"/>
              <a:gd name="connsiteY2" fmla="*/ 1289461 h 1289461"/>
              <a:gd name="connsiteX3" fmla="*/ 0 w 1934192"/>
              <a:gd name="connsiteY3" fmla="*/ 1289461 h 1289461"/>
              <a:gd name="connsiteX4" fmla="*/ 0 w 1934192"/>
              <a:gd name="connsiteY4" fmla="*/ 0 h 12894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934192" h="1289461">
                <a:moveTo>
                  <a:pt x="0" y="0"/>
                </a:moveTo>
                <a:lnTo>
                  <a:pt x="1934192" y="0"/>
                </a:lnTo>
                <a:lnTo>
                  <a:pt x="1934192" y="1289461"/>
                </a:lnTo>
                <a:lnTo>
                  <a:pt x="0" y="1289461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0" rIns="0" bIns="0" numCol="1" spcCol="1270" anchor="ctr" anchorCtr="0">
            <a:noAutofit/>
          </a:bodyPr>
          <a:lstStyle/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6) participatory politics</a:t>
            </a:r>
            <a:endParaRPr lang="ko-KR" altLang="en-US" sz="2000" dirty="0"/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7) unity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8) social justice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19) public hearing</a:t>
            </a:r>
            <a:endParaRPr lang="ko-KR" altLang="en-US" sz="2000" dirty="0"/>
          </a:p>
        </p:txBody>
      </p:sp>
      <p:sp>
        <p:nvSpPr>
          <p:cNvPr id="35" name="자유형: 도형 34">
            <a:extLst>
              <a:ext uri="{FF2B5EF4-FFF2-40B4-BE49-F238E27FC236}">
                <a16:creationId xmlns:a16="http://schemas.microsoft.com/office/drawing/2014/main" id="{125E6FC9-D0BF-46FC-91A9-8B443D30A37C}"/>
              </a:ext>
            </a:extLst>
          </p:cNvPr>
          <p:cNvSpPr/>
          <p:nvPr/>
        </p:nvSpPr>
        <p:spPr>
          <a:xfrm>
            <a:off x="8324051" y="1232945"/>
            <a:ext cx="4448266" cy="1468658"/>
          </a:xfrm>
          <a:custGeom>
            <a:avLst/>
            <a:gdLst>
              <a:gd name="connsiteX0" fmla="*/ 0 w 1934192"/>
              <a:gd name="connsiteY0" fmla="*/ 0 h 1289461"/>
              <a:gd name="connsiteX1" fmla="*/ 1934192 w 1934192"/>
              <a:gd name="connsiteY1" fmla="*/ 0 h 1289461"/>
              <a:gd name="connsiteX2" fmla="*/ 1934192 w 1934192"/>
              <a:gd name="connsiteY2" fmla="*/ 1289461 h 1289461"/>
              <a:gd name="connsiteX3" fmla="*/ 0 w 1934192"/>
              <a:gd name="connsiteY3" fmla="*/ 1289461 h 1289461"/>
              <a:gd name="connsiteX4" fmla="*/ 0 w 1934192"/>
              <a:gd name="connsiteY4" fmla="*/ 0 h 12894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934192" h="1289461">
                <a:moveTo>
                  <a:pt x="0" y="0"/>
                </a:moveTo>
                <a:lnTo>
                  <a:pt x="1934192" y="0"/>
                </a:lnTo>
                <a:lnTo>
                  <a:pt x="1934192" y="1289461"/>
                </a:lnTo>
                <a:lnTo>
                  <a:pt x="0" y="1289461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0" tIns="0" rIns="0" bIns="0" numCol="1" spcCol="1270" anchor="ctr" anchorCtr="0">
            <a:noAutofit/>
          </a:bodyPr>
          <a:lstStyle/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4) counselling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5) career/college advising </a:t>
            </a:r>
            <a:endParaRPr lang="ko-KR" altLang="en-US" sz="2000" dirty="0"/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6) scholarship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</a:pPr>
            <a:r>
              <a:rPr lang="en-US" altLang="ko-KR" sz="2000" dirty="0"/>
              <a:t>(7) Sunday school</a:t>
            </a:r>
          </a:p>
          <a:p>
            <a:pPr marL="0" lvl="1" defTabSz="977900" latinLnBrk="1">
              <a:lnSpc>
                <a:spcPct val="75000"/>
              </a:lnSpc>
              <a:spcBef>
                <a:spcPct val="0"/>
              </a:spcBef>
              <a:buChar char="•"/>
            </a:pPr>
            <a:endParaRPr lang="ko-KR" altLang="en-US" sz="2000" dirty="0"/>
          </a:p>
        </p:txBody>
      </p:sp>
      <p:sp>
        <p:nvSpPr>
          <p:cNvPr id="36" name="타원 35">
            <a:extLst>
              <a:ext uri="{FF2B5EF4-FFF2-40B4-BE49-F238E27FC236}">
                <a16:creationId xmlns:a16="http://schemas.microsoft.com/office/drawing/2014/main" id="{DAA38A29-2FB4-4A7F-96AA-59F2CDA27F9A}"/>
              </a:ext>
            </a:extLst>
          </p:cNvPr>
          <p:cNvSpPr/>
          <p:nvPr/>
        </p:nvSpPr>
        <p:spPr>
          <a:xfrm>
            <a:off x="76405" y="2988832"/>
            <a:ext cx="2392585" cy="934712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400" dirty="0"/>
              <a:t>sustainable</a:t>
            </a:r>
          </a:p>
          <a:p>
            <a:pPr algn="ctr"/>
            <a:r>
              <a:rPr lang="en-US" altLang="ko-KR" sz="2400" dirty="0"/>
              <a:t>potential</a:t>
            </a:r>
            <a:endParaRPr lang="ko-KR" altLang="en-US" sz="2400" dirty="0"/>
          </a:p>
        </p:txBody>
      </p:sp>
    </p:spTree>
    <p:extLst>
      <p:ext uri="{BB962C8B-B14F-4D97-AF65-F5344CB8AC3E}">
        <p14:creationId xmlns:p14="http://schemas.microsoft.com/office/powerpoint/2010/main" val="3431449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70</TotalTime>
  <Words>117</Words>
  <Application>Microsoft Office PowerPoint</Application>
  <PresentationFormat>와이드스크린</PresentationFormat>
  <Paragraphs>3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imchu</dc:creator>
  <cp:lastModifiedBy> </cp:lastModifiedBy>
  <cp:revision>22</cp:revision>
  <cp:lastPrinted>2020-07-07T16:48:44Z</cp:lastPrinted>
  <dcterms:created xsi:type="dcterms:W3CDTF">2020-07-04T16:39:35Z</dcterms:created>
  <dcterms:modified xsi:type="dcterms:W3CDTF">2020-07-13T11:26:35Z</dcterms:modified>
</cp:coreProperties>
</file>